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C61A5-C080-45F8-A2E6-03849EC9FE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1FE85-6472-418D-9FAA-D82B08DF31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9AF85-6CBA-49F3-BA4C-29ADCB987D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206B5-3554-4ED1-85E7-CA933C97AE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35C52-6462-487D-ACCE-32F7243233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E03AF-7114-46C5-B729-6640D72DF6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52B2E-0B65-40A4-85C3-7BCCA553C7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41156-8BD3-4A7D-BF9D-2788170824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28106-5D57-4311-B134-E77FF6F088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DCA4E-F66D-4FD6-BBA6-378B6B1BC3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B0897-D23A-4A8A-9918-66E755457D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13109-4A24-4F45-BB87-07A4946AC6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BE39D1-B3C4-4567-95D1-48F663C1235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5"/>
          <p:cNvGrpSpPr/>
          <p:nvPr/>
        </p:nvGrpSpPr>
        <p:grpSpPr>
          <a:xfrm>
            <a:off x="1481040" y="1504800"/>
            <a:ext cx="4491000" cy="3064320"/>
            <a:chOff x="1481040" y="1504800"/>
            <a:chExt cx="4491000" cy="3064320"/>
          </a:xfrm>
        </p:grpSpPr>
        <p:sp>
          <p:nvSpPr>
            <p:cNvPr id="42" name="Text Box 5"/>
            <p:cNvSpPr/>
            <p:nvPr/>
          </p:nvSpPr>
          <p:spPr>
            <a:xfrm rot="16200000">
              <a:off x="741960" y="2826720"/>
              <a:ext cx="1754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umor Volume (mm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Chart 3" descr=""/>
            <p:cNvPicPr/>
            <p:nvPr/>
          </p:nvPicPr>
          <p:blipFill>
            <a:blip r:embed="rId1"/>
            <a:stretch/>
          </p:blipFill>
          <p:spPr>
            <a:xfrm>
              <a:off x="1639440" y="1504800"/>
              <a:ext cx="4332600" cy="282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9"/>
            <p:cNvSpPr/>
            <p:nvPr/>
          </p:nvSpPr>
          <p:spPr>
            <a:xfrm>
              <a:off x="2073960" y="250164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70c0"/>
                  </a:solidFill>
                  <a:latin typeface="Arial"/>
                  <a:ea typeface="宋体"/>
                </a:rPr>
                <a:t>Treatmen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23"/>
            <p:cNvSpPr/>
            <p:nvPr/>
          </p:nvSpPr>
          <p:spPr>
            <a:xfrm>
              <a:off x="3094560" y="2557440"/>
              <a:ext cx="0" cy="142200"/>
            </a:xfrm>
            <a:prstGeom prst="line">
              <a:avLst/>
            </a:prstGeom>
            <a:ln w="19080">
              <a:solidFill>
                <a:srgbClr val="0070c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5"/>
            <p:cNvSpPr/>
            <p:nvPr/>
          </p:nvSpPr>
          <p:spPr>
            <a:xfrm>
              <a:off x="2592000" y="2840400"/>
              <a:ext cx="0" cy="165600"/>
            </a:xfrm>
            <a:prstGeom prst="line">
              <a:avLst/>
            </a:prstGeom>
            <a:ln w="19080">
              <a:solidFill>
                <a:srgbClr val="0070c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23"/>
            <p:cNvSpPr/>
            <p:nvPr/>
          </p:nvSpPr>
          <p:spPr>
            <a:xfrm>
              <a:off x="3606120" y="2300760"/>
              <a:ext cx="0" cy="143640"/>
            </a:xfrm>
            <a:prstGeom prst="line">
              <a:avLst/>
            </a:prstGeom>
            <a:ln w="19080">
              <a:solidFill>
                <a:srgbClr val="0070c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23"/>
            <p:cNvSpPr/>
            <p:nvPr/>
          </p:nvSpPr>
          <p:spPr>
            <a:xfrm>
              <a:off x="4108680" y="1951200"/>
              <a:ext cx="0" cy="142200"/>
            </a:xfrm>
            <a:prstGeom prst="line">
              <a:avLst/>
            </a:prstGeom>
            <a:ln w="19080">
              <a:solidFill>
                <a:srgbClr val="0070c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9"/>
            <p:cNvSpPr/>
            <p:nvPr/>
          </p:nvSpPr>
          <p:spPr>
            <a:xfrm>
              <a:off x="2324160" y="3759480"/>
              <a:ext cx="199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&lt;0.04,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*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&lt;0.015 vs 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8"/>
            <p:cNvSpPr/>
            <p:nvPr/>
          </p:nvSpPr>
          <p:spPr>
            <a:xfrm>
              <a:off x="3951720" y="3323160"/>
              <a:ext cx="348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0"/>
            <p:cNvSpPr/>
            <p:nvPr/>
          </p:nvSpPr>
          <p:spPr>
            <a:xfrm>
              <a:off x="3492360" y="31827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8"/>
            <p:cNvSpPr/>
            <p:nvPr/>
          </p:nvSpPr>
          <p:spPr>
            <a:xfrm>
              <a:off x="4446000" y="3463920"/>
              <a:ext cx="348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6"/>
            <p:cNvSpPr/>
            <p:nvPr/>
          </p:nvSpPr>
          <p:spPr>
            <a:xfrm>
              <a:off x="2162880" y="4307760"/>
              <a:ext cx="242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ays post injection of tumor cell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7"/>
            <p:cNvSpPr/>
            <p:nvPr/>
          </p:nvSpPr>
          <p:spPr>
            <a:xfrm>
              <a:off x="1915200" y="4117680"/>
              <a:ext cx="2936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6         31         34          38         41         4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 Box 14"/>
          <p:cNvSpPr/>
          <p:nvPr/>
        </p:nvSpPr>
        <p:spPr>
          <a:xfrm>
            <a:off x="2447640" y="7997760"/>
            <a:ext cx="172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ang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. 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3T17:46:49Z</dcterms:created>
  <dc:creator>Liu, Bolin</dc:creator>
  <dc:description/>
  <dc:language>en-US</dc:language>
  <cp:lastModifiedBy>Liu, Bolin</cp:lastModifiedBy>
  <dcterms:modified xsi:type="dcterms:W3CDTF">2013-08-30T16:10:38Z</dcterms:modified>
  <cp:revision>194</cp:revision>
  <dc:subject/>
  <dc:title>Slide 1</dc:title>
</cp:coreProperties>
</file>